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7" autoAdjust="0"/>
    <p:restoredTop sz="94660"/>
  </p:normalViewPr>
  <p:slideViewPr>
    <p:cSldViewPr snapToGrid="0">
      <p:cViewPr varScale="1">
        <p:scale>
          <a:sx n="75" d="100"/>
          <a:sy n="75" d="100"/>
        </p:scale>
        <p:origin x="2237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makawa Ginga" userId="274c281c390bf037" providerId="LiveId" clId="{84E950BA-7236-4EFF-A30F-C57B20193290}"/>
    <pc:docChg chg="custSel addSld delSld modSld">
      <pc:chgData name="Shimakawa Ginga" userId="274c281c390bf037" providerId="LiveId" clId="{84E950BA-7236-4EFF-A30F-C57B20193290}" dt="2021-06-15T01:08:42.495" v="1285" actId="114"/>
      <pc:docMkLst>
        <pc:docMk/>
      </pc:docMkLst>
      <pc:sldChg chg="addSp delSp modSp mod">
        <pc:chgData name="Shimakawa Ginga" userId="274c281c390bf037" providerId="LiveId" clId="{84E950BA-7236-4EFF-A30F-C57B20193290}" dt="2021-06-14T09:02:30.043" v="348" actId="20577"/>
        <pc:sldMkLst>
          <pc:docMk/>
          <pc:sldMk cId="3549244890" sldId="277"/>
        </pc:sldMkLst>
        <pc:spChg chg="del mod">
          <ac:chgData name="Shimakawa Ginga" userId="274c281c390bf037" providerId="LiveId" clId="{84E950BA-7236-4EFF-A30F-C57B20193290}" dt="2021-06-13T01:59:13.099" v="50" actId="21"/>
          <ac:spMkLst>
            <pc:docMk/>
            <pc:sldMk cId="3549244890" sldId="277"/>
            <ac:spMk id="5" creationId="{3C20FDA5-844D-4742-BAC3-4B023F6AF411}"/>
          </ac:spMkLst>
        </pc:spChg>
        <pc:spChg chg="add mod">
          <ac:chgData name="Shimakawa Ginga" userId="274c281c390bf037" providerId="LiveId" clId="{84E950BA-7236-4EFF-A30F-C57B20193290}" dt="2021-06-14T09:02:30.043" v="348" actId="20577"/>
          <ac:spMkLst>
            <pc:docMk/>
            <pc:sldMk cId="3549244890" sldId="277"/>
            <ac:spMk id="7" creationId="{C9A579CE-4FBD-4D9C-84C6-09B8E4C7E636}"/>
          </ac:spMkLst>
        </pc:spChg>
        <pc:picChg chg="del mod">
          <ac:chgData name="Shimakawa Ginga" userId="274c281c390bf037" providerId="LiveId" clId="{84E950BA-7236-4EFF-A30F-C57B20193290}" dt="2021-06-13T01:58:19.643" v="47" actId="21"/>
          <ac:picMkLst>
            <pc:docMk/>
            <pc:sldMk cId="3549244890" sldId="277"/>
            <ac:picMk id="3" creationId="{356FCADC-C6C2-4332-8B11-CB9F0AD4BE13}"/>
          </ac:picMkLst>
        </pc:picChg>
        <pc:picChg chg="add mod">
          <ac:chgData name="Shimakawa Ginga" userId="274c281c390bf037" providerId="LiveId" clId="{84E950BA-7236-4EFF-A30F-C57B20193290}" dt="2021-06-13T01:58:27.580" v="49" actId="1076"/>
          <ac:picMkLst>
            <pc:docMk/>
            <pc:sldMk cId="3549244890" sldId="277"/>
            <ac:picMk id="6" creationId="{9BF5C072-63EA-4415-A282-C72490F18C2D}"/>
          </ac:picMkLst>
        </pc:picChg>
      </pc:sldChg>
      <pc:sldChg chg="addSp delSp modSp add mod">
        <pc:chgData name="Shimakawa Ginga" userId="274c281c390bf037" providerId="LiveId" clId="{84E950BA-7236-4EFF-A30F-C57B20193290}" dt="2021-06-15T01:08:42.495" v="1285" actId="114"/>
        <pc:sldMkLst>
          <pc:docMk/>
          <pc:sldMk cId="801605879" sldId="280"/>
        </pc:sldMkLst>
        <pc:spChg chg="mod">
          <ac:chgData name="Shimakawa Ginga" userId="274c281c390bf037" providerId="LiveId" clId="{84E950BA-7236-4EFF-A30F-C57B20193290}" dt="2021-06-13T23:41:13.910" v="292" actId="20577"/>
          <ac:spMkLst>
            <pc:docMk/>
            <pc:sldMk cId="801605879" sldId="280"/>
            <ac:spMk id="4" creationId="{9CC83B6F-C717-4187-81C4-9E7E47AB7D60}"/>
          </ac:spMkLst>
        </pc:spChg>
        <pc:spChg chg="mod">
          <ac:chgData name="Shimakawa Ginga" userId="274c281c390bf037" providerId="LiveId" clId="{84E950BA-7236-4EFF-A30F-C57B20193290}" dt="2021-06-15T01:08:42.495" v="1285" actId="114"/>
          <ac:spMkLst>
            <pc:docMk/>
            <pc:sldMk cId="801605879" sldId="280"/>
            <ac:spMk id="5" creationId="{3C20FDA5-844D-4742-BAC3-4B023F6AF411}"/>
          </ac:spMkLst>
        </pc:spChg>
        <pc:picChg chg="add del mod">
          <ac:chgData name="Shimakawa Ginga" userId="274c281c390bf037" providerId="LiveId" clId="{84E950BA-7236-4EFF-A30F-C57B20193290}" dt="2021-06-15T00:13:50.965" v="371" actId="21"/>
          <ac:picMkLst>
            <pc:docMk/>
            <pc:sldMk cId="801605879" sldId="280"/>
            <ac:picMk id="3" creationId="{187525DF-790A-46BA-81E9-2B5BB9C32242}"/>
          </ac:picMkLst>
        </pc:picChg>
        <pc:picChg chg="del">
          <ac:chgData name="Shimakawa Ginga" userId="274c281c390bf037" providerId="LiveId" clId="{84E950BA-7236-4EFF-A30F-C57B20193290}" dt="2021-06-15T00:13:36.603" v="369" actId="21"/>
          <ac:picMkLst>
            <pc:docMk/>
            <pc:sldMk cId="801605879" sldId="280"/>
            <ac:picMk id="6" creationId="{5F8B1641-F5B2-4047-AF11-E7F42A7A356E}"/>
          </ac:picMkLst>
        </pc:picChg>
        <pc:picChg chg="add mod">
          <ac:chgData name="Shimakawa Ginga" userId="274c281c390bf037" providerId="LiveId" clId="{84E950BA-7236-4EFF-A30F-C57B20193290}" dt="2021-06-15T00:14:37.091" v="379" actId="1076"/>
          <ac:picMkLst>
            <pc:docMk/>
            <pc:sldMk cId="801605879" sldId="280"/>
            <ac:picMk id="8" creationId="{27A2298E-5BB1-49AD-AC3E-CCBC03B22BEF}"/>
          </ac:picMkLst>
        </pc:picChg>
      </pc:sldChg>
      <pc:sldChg chg="modSp mod">
        <pc:chgData name="Shimakawa Ginga" userId="274c281c390bf037" providerId="LiveId" clId="{84E950BA-7236-4EFF-A30F-C57B20193290}" dt="2021-06-13T23:42:50.717" v="340" actId="20577"/>
        <pc:sldMkLst>
          <pc:docMk/>
          <pc:sldMk cId="4120038439" sldId="284"/>
        </pc:sldMkLst>
        <pc:spChg chg="mod">
          <ac:chgData name="Shimakawa Ginga" userId="274c281c390bf037" providerId="LiveId" clId="{84E950BA-7236-4EFF-A30F-C57B20193290}" dt="2021-06-13T23:42:50.717" v="340" actId="20577"/>
          <ac:spMkLst>
            <pc:docMk/>
            <pc:sldMk cId="4120038439" sldId="284"/>
            <ac:spMk id="5" creationId="{3C20FDA5-844D-4742-BAC3-4B023F6AF411}"/>
          </ac:spMkLst>
        </pc:spChg>
      </pc:sldChg>
      <pc:sldChg chg="modSp mod">
        <pc:chgData name="Shimakawa Ginga" userId="274c281c390bf037" providerId="LiveId" clId="{84E950BA-7236-4EFF-A30F-C57B20193290}" dt="2021-06-13T23:42:35.109" v="328" actId="20577"/>
        <pc:sldMkLst>
          <pc:docMk/>
          <pc:sldMk cId="3542704458" sldId="288"/>
        </pc:sldMkLst>
        <pc:spChg chg="mod">
          <ac:chgData name="Shimakawa Ginga" userId="274c281c390bf037" providerId="LiveId" clId="{84E950BA-7236-4EFF-A30F-C57B20193290}" dt="2021-06-13T01:59:52.266" v="61" actId="20577"/>
          <ac:spMkLst>
            <pc:docMk/>
            <pc:sldMk cId="3542704458" sldId="288"/>
            <ac:spMk id="4" creationId="{9CC83B6F-C717-4187-81C4-9E7E47AB7D60}"/>
          </ac:spMkLst>
        </pc:spChg>
        <pc:spChg chg="mod">
          <ac:chgData name="Shimakawa Ginga" userId="274c281c390bf037" providerId="LiveId" clId="{84E950BA-7236-4EFF-A30F-C57B20193290}" dt="2021-06-13T23:42:35.109" v="328" actId="20577"/>
          <ac:spMkLst>
            <pc:docMk/>
            <pc:sldMk cId="3542704458" sldId="288"/>
            <ac:spMk id="5" creationId="{3C20FDA5-844D-4742-BAC3-4B023F6AF411}"/>
          </ac:spMkLst>
        </pc:spChg>
      </pc:sldChg>
      <pc:sldChg chg="modSp mod">
        <pc:chgData name="Shimakawa Ginga" userId="274c281c390bf037" providerId="LiveId" clId="{84E950BA-7236-4EFF-A30F-C57B20193290}" dt="2021-06-14T09:08:09.265" v="368" actId="20577"/>
        <pc:sldMkLst>
          <pc:docMk/>
          <pc:sldMk cId="1440977981" sldId="289"/>
        </pc:sldMkLst>
        <pc:spChg chg="mod">
          <ac:chgData name="Shimakawa Ginga" userId="274c281c390bf037" providerId="LiveId" clId="{84E950BA-7236-4EFF-A30F-C57B20193290}" dt="2021-06-13T01:59:44.510" v="57" actId="20577"/>
          <ac:spMkLst>
            <pc:docMk/>
            <pc:sldMk cId="1440977981" sldId="289"/>
            <ac:spMk id="4" creationId="{9CC83B6F-C717-4187-81C4-9E7E47AB7D60}"/>
          </ac:spMkLst>
        </pc:spChg>
        <pc:spChg chg="mod">
          <ac:chgData name="Shimakawa Ginga" userId="274c281c390bf037" providerId="LiveId" clId="{84E950BA-7236-4EFF-A30F-C57B20193290}" dt="2021-06-14T09:08:09.265" v="368" actId="20577"/>
          <ac:spMkLst>
            <pc:docMk/>
            <pc:sldMk cId="1440977981" sldId="289"/>
            <ac:spMk id="5" creationId="{3C20FDA5-844D-4742-BAC3-4B023F6AF411}"/>
          </ac:spMkLst>
        </pc:spChg>
      </pc:sldChg>
      <pc:sldChg chg="modSp mod">
        <pc:chgData name="Shimakawa Ginga" userId="274c281c390bf037" providerId="LiveId" clId="{84E950BA-7236-4EFF-A30F-C57B20193290}" dt="2021-06-13T23:42:23.318" v="320" actId="20577"/>
        <pc:sldMkLst>
          <pc:docMk/>
          <pc:sldMk cId="2726171640" sldId="290"/>
        </pc:sldMkLst>
        <pc:spChg chg="mod">
          <ac:chgData name="Shimakawa Ginga" userId="274c281c390bf037" providerId="LiveId" clId="{84E950BA-7236-4EFF-A30F-C57B20193290}" dt="2021-06-13T04:29:20.798" v="146" actId="20577"/>
          <ac:spMkLst>
            <pc:docMk/>
            <pc:sldMk cId="2726171640" sldId="290"/>
            <ac:spMk id="4" creationId="{9CC83B6F-C717-4187-81C4-9E7E47AB7D60}"/>
          </ac:spMkLst>
        </pc:spChg>
        <pc:spChg chg="mod">
          <ac:chgData name="Shimakawa Ginga" userId="274c281c390bf037" providerId="LiveId" clId="{84E950BA-7236-4EFF-A30F-C57B20193290}" dt="2021-06-13T23:42:23.318" v="320" actId="20577"/>
          <ac:spMkLst>
            <pc:docMk/>
            <pc:sldMk cId="2726171640" sldId="290"/>
            <ac:spMk id="5" creationId="{3C20FDA5-844D-4742-BAC3-4B023F6AF411}"/>
          </ac:spMkLst>
        </pc:spChg>
      </pc:sldChg>
      <pc:sldChg chg="modSp mod">
        <pc:chgData name="Shimakawa Ginga" userId="274c281c390bf037" providerId="LiveId" clId="{84E950BA-7236-4EFF-A30F-C57B20193290}" dt="2021-06-13T23:41:57.167" v="316" actId="20577"/>
        <pc:sldMkLst>
          <pc:docMk/>
          <pc:sldMk cId="880047741" sldId="291"/>
        </pc:sldMkLst>
        <pc:spChg chg="mod">
          <ac:chgData name="Shimakawa Ginga" userId="274c281c390bf037" providerId="LiveId" clId="{84E950BA-7236-4EFF-A30F-C57B20193290}" dt="2021-06-13T04:29:32.014" v="152" actId="20577"/>
          <ac:spMkLst>
            <pc:docMk/>
            <pc:sldMk cId="880047741" sldId="291"/>
            <ac:spMk id="4" creationId="{9CC83B6F-C717-4187-81C4-9E7E47AB7D60}"/>
          </ac:spMkLst>
        </pc:spChg>
        <pc:spChg chg="mod">
          <ac:chgData name="Shimakawa Ginga" userId="274c281c390bf037" providerId="LiveId" clId="{84E950BA-7236-4EFF-A30F-C57B20193290}" dt="2021-06-13T23:41:57.167" v="316" actId="20577"/>
          <ac:spMkLst>
            <pc:docMk/>
            <pc:sldMk cId="880047741" sldId="291"/>
            <ac:spMk id="5" creationId="{3C20FDA5-844D-4742-BAC3-4B023F6AF411}"/>
          </ac:spMkLst>
        </pc:spChg>
      </pc:sldChg>
      <pc:sldChg chg="add del">
        <pc:chgData name="Shimakawa Ginga" userId="274c281c390bf037" providerId="LiveId" clId="{84E950BA-7236-4EFF-A30F-C57B20193290}" dt="2021-06-13T01:59:23.067" v="53" actId="2696"/>
        <pc:sldMkLst>
          <pc:docMk/>
          <pc:sldMk cId="455454835" sldId="292"/>
        </pc:sldMkLst>
      </pc:sldChg>
      <pc:sldChg chg="addSp delSp modSp add mod">
        <pc:chgData name="Shimakawa Ginga" userId="274c281c390bf037" providerId="LiveId" clId="{84E950BA-7236-4EFF-A30F-C57B20193290}" dt="2021-06-14T09:06:17.230" v="349" actId="6549"/>
        <pc:sldMkLst>
          <pc:docMk/>
          <pc:sldMk cId="1650464212" sldId="292"/>
        </pc:sldMkLst>
        <pc:spChg chg="mod">
          <ac:chgData name="Shimakawa Ginga" userId="274c281c390bf037" providerId="LiveId" clId="{84E950BA-7236-4EFF-A30F-C57B20193290}" dt="2021-06-13T02:00:38.075" v="76" actId="20577"/>
          <ac:spMkLst>
            <pc:docMk/>
            <pc:sldMk cId="1650464212" sldId="292"/>
            <ac:spMk id="4" creationId="{9CC83B6F-C717-4187-81C4-9E7E47AB7D60}"/>
          </ac:spMkLst>
        </pc:spChg>
        <pc:spChg chg="mod">
          <ac:chgData name="Shimakawa Ginga" userId="274c281c390bf037" providerId="LiveId" clId="{84E950BA-7236-4EFF-A30F-C57B20193290}" dt="2021-06-14T09:06:17.230" v="349" actId="6549"/>
          <ac:spMkLst>
            <pc:docMk/>
            <pc:sldMk cId="1650464212" sldId="292"/>
            <ac:spMk id="5" creationId="{3C20FDA5-844D-4742-BAC3-4B023F6AF411}"/>
          </ac:spMkLst>
        </pc:spChg>
        <pc:picChg chg="del">
          <ac:chgData name="Shimakawa Ginga" userId="274c281c390bf037" providerId="LiveId" clId="{84E950BA-7236-4EFF-A30F-C57B20193290}" dt="2021-06-13T02:20:21.312" v="111" actId="21"/>
          <ac:picMkLst>
            <pc:docMk/>
            <pc:sldMk cId="1650464212" sldId="292"/>
            <ac:picMk id="3" creationId="{87DC5A32-C3F5-4348-B6BE-7265C2075085}"/>
          </ac:picMkLst>
        </pc:picChg>
        <pc:picChg chg="add del mod">
          <ac:chgData name="Shimakawa Ginga" userId="274c281c390bf037" providerId="LiveId" clId="{84E950BA-7236-4EFF-A30F-C57B20193290}" dt="2021-06-13T02:07:04.169" v="106" actId="21"/>
          <ac:picMkLst>
            <pc:docMk/>
            <pc:sldMk cId="1650464212" sldId="292"/>
            <ac:picMk id="6" creationId="{A3A2F98E-76CD-479E-8499-639E5FE76030}"/>
          </ac:picMkLst>
        </pc:picChg>
        <pc:picChg chg="add mod ord">
          <ac:chgData name="Shimakawa Ginga" userId="274c281c390bf037" providerId="LiveId" clId="{84E950BA-7236-4EFF-A30F-C57B20193290}" dt="2021-06-13T02:20:20.264" v="110" actId="167"/>
          <ac:picMkLst>
            <pc:docMk/>
            <pc:sldMk cId="1650464212" sldId="292"/>
            <ac:picMk id="8" creationId="{E93F064D-087B-4722-B62D-D7228021D8E5}"/>
          </ac:picMkLst>
        </pc:picChg>
      </pc:sldChg>
      <pc:sldChg chg="addSp delSp modSp add mod">
        <pc:chgData name="Shimakawa Ginga" userId="274c281c390bf037" providerId="LiveId" clId="{84E950BA-7236-4EFF-A30F-C57B20193290}" dt="2021-06-13T23:42:30.461" v="324" actId="20577"/>
        <pc:sldMkLst>
          <pc:docMk/>
          <pc:sldMk cId="191764055" sldId="293"/>
        </pc:sldMkLst>
        <pc:spChg chg="mod">
          <ac:chgData name="Shimakawa Ginga" userId="274c281c390bf037" providerId="LiveId" clId="{84E950BA-7236-4EFF-A30F-C57B20193290}" dt="2021-06-13T23:42:30.461" v="324" actId="20577"/>
          <ac:spMkLst>
            <pc:docMk/>
            <pc:sldMk cId="191764055" sldId="293"/>
            <ac:spMk id="5" creationId="{869C8A62-577E-4773-8155-874C4FBFE288}"/>
          </ac:spMkLst>
        </pc:spChg>
        <pc:spChg chg="mod">
          <ac:chgData name="Shimakawa Ginga" userId="274c281c390bf037" providerId="LiveId" clId="{84E950BA-7236-4EFF-A30F-C57B20193290}" dt="2021-06-13T04:29:11.598" v="144" actId="20577"/>
          <ac:spMkLst>
            <pc:docMk/>
            <pc:sldMk cId="191764055" sldId="293"/>
            <ac:spMk id="2052" creationId="{D0B93345-6DFD-4D1D-AC73-838654A25106}"/>
          </ac:spMkLst>
        </pc:spChg>
        <pc:picChg chg="add del mod">
          <ac:chgData name="Shimakawa Ginga" userId="274c281c390bf037" providerId="LiveId" clId="{84E950BA-7236-4EFF-A30F-C57B20193290}" dt="2021-06-13T12:25:17.924" v="271" actId="21"/>
          <ac:picMkLst>
            <pc:docMk/>
            <pc:sldMk cId="191764055" sldId="293"/>
            <ac:picMk id="3" creationId="{276EC15C-B779-44C3-8A26-3498DBCF7E4B}"/>
          </ac:picMkLst>
        </pc:picChg>
        <pc:picChg chg="del">
          <ac:chgData name="Shimakawa Ginga" userId="274c281c390bf037" providerId="LiveId" clId="{84E950BA-7236-4EFF-A30F-C57B20193290}" dt="2021-06-13T04:29:51.081" v="153" actId="21"/>
          <ac:picMkLst>
            <pc:docMk/>
            <pc:sldMk cId="191764055" sldId="293"/>
            <ac:picMk id="4" creationId="{EA258690-B65E-49D6-9931-BD96CF7B71EF}"/>
          </ac:picMkLst>
        </pc:picChg>
        <pc:picChg chg="add mod">
          <ac:chgData name="Shimakawa Ginga" userId="274c281c390bf037" providerId="LiveId" clId="{84E950BA-7236-4EFF-A30F-C57B20193290}" dt="2021-06-13T12:26:08.521" v="273" actId="1076"/>
          <ac:picMkLst>
            <pc:docMk/>
            <pc:sldMk cId="191764055" sldId="293"/>
            <ac:picMk id="6" creationId="{6772542E-CE35-4009-8C2D-5D702159A528}"/>
          </ac:picMkLst>
        </pc:picChg>
      </pc:sldChg>
    </pc:docChg>
  </pc:docChgLst>
  <pc:docChgLst>
    <pc:chgData name="Shimakawa Ginga" userId="274c281c390bf037" providerId="LiveId" clId="{A41CC40D-1628-48AD-83F2-CD659B7B330E}"/>
    <pc:docChg chg="addSld delSld modSld">
      <pc:chgData name="Shimakawa Ginga" userId="274c281c390bf037" providerId="LiveId" clId="{A41CC40D-1628-48AD-83F2-CD659B7B330E}" dt="2021-06-28T12:35:05.879" v="23" actId="2696"/>
      <pc:docMkLst>
        <pc:docMk/>
      </pc:docMkLst>
      <pc:sldChg chg="del">
        <pc:chgData name="Shimakawa Ginga" userId="274c281c390bf037" providerId="LiveId" clId="{A41CC40D-1628-48AD-83F2-CD659B7B330E}" dt="2021-06-28T12:32:56.164" v="0" actId="2696"/>
        <pc:sldMkLst>
          <pc:docMk/>
          <pc:sldMk cId="3549244890" sldId="277"/>
        </pc:sldMkLst>
      </pc:sldChg>
      <pc:sldChg chg="del">
        <pc:chgData name="Shimakawa Ginga" userId="274c281c390bf037" providerId="LiveId" clId="{A41CC40D-1628-48AD-83F2-CD659B7B330E}" dt="2021-06-28T12:33:09.302" v="2" actId="2696"/>
        <pc:sldMkLst>
          <pc:docMk/>
          <pc:sldMk cId="801605879" sldId="280"/>
        </pc:sldMkLst>
      </pc:sldChg>
      <pc:sldChg chg="del">
        <pc:chgData name="Shimakawa Ginga" userId="274c281c390bf037" providerId="LiveId" clId="{A41CC40D-1628-48AD-83F2-CD659B7B330E}" dt="2021-06-28T12:32:56.164" v="0" actId="2696"/>
        <pc:sldMkLst>
          <pc:docMk/>
          <pc:sldMk cId="4120038439" sldId="284"/>
        </pc:sldMkLst>
      </pc:sldChg>
      <pc:sldChg chg="del">
        <pc:chgData name="Shimakawa Ginga" userId="274c281c390bf037" providerId="LiveId" clId="{A41CC40D-1628-48AD-83F2-CD659B7B330E}" dt="2021-06-28T12:35:05.879" v="23" actId="2696"/>
        <pc:sldMkLst>
          <pc:docMk/>
          <pc:sldMk cId="3542704458" sldId="288"/>
        </pc:sldMkLst>
      </pc:sldChg>
      <pc:sldChg chg="del">
        <pc:chgData name="Shimakawa Ginga" userId="274c281c390bf037" providerId="LiveId" clId="{A41CC40D-1628-48AD-83F2-CD659B7B330E}" dt="2021-06-28T12:33:01.516" v="1" actId="2696"/>
        <pc:sldMkLst>
          <pc:docMk/>
          <pc:sldMk cId="1440977981" sldId="289"/>
        </pc:sldMkLst>
      </pc:sldChg>
      <pc:sldChg chg="addSp delSp modSp add mod">
        <pc:chgData name="Shimakawa Ginga" userId="274c281c390bf037" providerId="LiveId" clId="{A41CC40D-1628-48AD-83F2-CD659B7B330E}" dt="2021-06-28T12:34:38.196" v="22" actId="20577"/>
        <pc:sldMkLst>
          <pc:docMk/>
          <pc:sldMk cId="1583524438" sldId="289"/>
        </pc:sldMkLst>
        <pc:spChg chg="del">
          <ac:chgData name="Shimakawa Ginga" userId="274c281c390bf037" providerId="LiveId" clId="{A41CC40D-1628-48AD-83F2-CD659B7B330E}" dt="2021-06-28T12:34:16.771" v="4" actId="21"/>
          <ac:spMkLst>
            <pc:docMk/>
            <pc:sldMk cId="1583524438" sldId="289"/>
            <ac:spMk id="4" creationId="{9CC83B6F-C717-4187-81C4-9E7E47AB7D60}"/>
          </ac:spMkLst>
        </pc:spChg>
        <pc:spChg chg="mod">
          <ac:chgData name="Shimakawa Ginga" userId="274c281c390bf037" providerId="LiveId" clId="{A41CC40D-1628-48AD-83F2-CD659B7B330E}" dt="2021-06-28T12:34:38.196" v="22" actId="20577"/>
          <ac:spMkLst>
            <pc:docMk/>
            <pc:sldMk cId="1583524438" sldId="289"/>
            <ac:spMk id="5" creationId="{3C20FDA5-844D-4742-BAC3-4B023F6AF411}"/>
          </ac:spMkLst>
        </pc:spChg>
        <pc:spChg chg="add mod">
          <ac:chgData name="Shimakawa Ginga" userId="274c281c390bf037" providerId="LiveId" clId="{A41CC40D-1628-48AD-83F2-CD659B7B330E}" dt="2021-06-28T12:34:24.769" v="7" actId="20577"/>
          <ac:spMkLst>
            <pc:docMk/>
            <pc:sldMk cId="1583524438" sldId="289"/>
            <ac:spMk id="6" creationId="{FDEC9529-0B28-4DB4-A4F5-E057FAA127B9}"/>
          </ac:spMkLst>
        </pc:spChg>
        <pc:picChg chg="mod">
          <ac:chgData name="Shimakawa Ginga" userId="274c281c390bf037" providerId="LiveId" clId="{A41CC40D-1628-48AD-83F2-CD659B7B330E}" dt="2021-06-28T12:34:28.743" v="8" actId="14100"/>
          <ac:picMkLst>
            <pc:docMk/>
            <pc:sldMk cId="1583524438" sldId="289"/>
            <ac:picMk id="3" creationId="{98B1A076-40BB-4A39-9698-FAC6BF1D5B73}"/>
          </ac:picMkLst>
        </pc:picChg>
      </pc:sldChg>
      <pc:sldChg chg="del">
        <pc:chgData name="Shimakawa Ginga" userId="274c281c390bf037" providerId="LiveId" clId="{A41CC40D-1628-48AD-83F2-CD659B7B330E}" dt="2021-06-28T12:35:05.879" v="23" actId="2696"/>
        <pc:sldMkLst>
          <pc:docMk/>
          <pc:sldMk cId="2726171640" sldId="290"/>
        </pc:sldMkLst>
      </pc:sldChg>
      <pc:sldChg chg="del">
        <pc:chgData name="Shimakawa Ginga" userId="274c281c390bf037" providerId="LiveId" clId="{A41CC40D-1628-48AD-83F2-CD659B7B330E}" dt="2021-06-28T12:35:05.879" v="23" actId="2696"/>
        <pc:sldMkLst>
          <pc:docMk/>
          <pc:sldMk cId="880047741" sldId="291"/>
        </pc:sldMkLst>
      </pc:sldChg>
      <pc:sldChg chg="del">
        <pc:chgData name="Shimakawa Ginga" userId="274c281c390bf037" providerId="LiveId" clId="{A41CC40D-1628-48AD-83F2-CD659B7B330E}" dt="2021-06-28T12:32:56.164" v="0" actId="2696"/>
        <pc:sldMkLst>
          <pc:docMk/>
          <pc:sldMk cId="1650464212" sldId="292"/>
        </pc:sldMkLst>
      </pc:sldChg>
      <pc:sldChg chg="del">
        <pc:chgData name="Shimakawa Ginga" userId="274c281c390bf037" providerId="LiveId" clId="{A41CC40D-1628-48AD-83F2-CD659B7B330E}" dt="2021-06-28T12:35:05.879" v="23" actId="2696"/>
        <pc:sldMkLst>
          <pc:docMk/>
          <pc:sldMk cId="191764055" sldId="293"/>
        </pc:sldMkLst>
      </pc:sldChg>
    </pc:docChg>
  </pc:docChgLst>
  <pc:docChgLst>
    <pc:chgData name="Shimakawa Ginga" userId="274c281c390bf037" providerId="LiveId" clId="{3508078A-B217-4536-9942-D96F763829E6}"/>
    <pc:docChg chg="delSld">
      <pc:chgData name="Shimakawa Ginga" userId="274c281c390bf037" providerId="LiveId" clId="{3508078A-B217-4536-9942-D96F763829E6}" dt="2021-02-17T08:53:47.307" v="0" actId="2696"/>
      <pc:docMkLst>
        <pc:docMk/>
      </pc:docMkLst>
      <pc:sldChg chg="del">
        <pc:chgData name="Shimakawa Ginga" userId="274c281c390bf037" providerId="LiveId" clId="{3508078A-B217-4536-9942-D96F763829E6}" dt="2021-02-17T08:53:47.307" v="0" actId="2696"/>
        <pc:sldMkLst>
          <pc:docMk/>
          <pc:sldMk cId="1312149010" sldId="269"/>
        </pc:sldMkLst>
      </pc:sldChg>
      <pc:sldChg chg="del">
        <pc:chgData name="Shimakawa Ginga" userId="274c281c390bf037" providerId="LiveId" clId="{3508078A-B217-4536-9942-D96F763829E6}" dt="2021-02-17T08:53:47.307" v="0" actId="2696"/>
        <pc:sldMkLst>
          <pc:docMk/>
          <pc:sldMk cId="801605879" sldId="280"/>
        </pc:sldMkLst>
      </pc:sldChg>
      <pc:sldChg chg="del">
        <pc:chgData name="Shimakawa Ginga" userId="274c281c390bf037" providerId="LiveId" clId="{3508078A-B217-4536-9942-D96F763829E6}" dt="2021-02-17T08:53:47.307" v="0" actId="2696"/>
        <pc:sldMkLst>
          <pc:docMk/>
          <pc:sldMk cId="3309893148" sldId="282"/>
        </pc:sldMkLst>
      </pc:sldChg>
      <pc:sldChg chg="del">
        <pc:chgData name="Shimakawa Ginga" userId="274c281c390bf037" providerId="LiveId" clId="{3508078A-B217-4536-9942-D96F763829E6}" dt="2021-02-17T08:53:47.307" v="0" actId="2696"/>
        <pc:sldMkLst>
          <pc:docMk/>
          <pc:sldMk cId="997239038" sldId="285"/>
        </pc:sldMkLst>
      </pc:sldChg>
      <pc:sldChg chg="del">
        <pc:chgData name="Shimakawa Ginga" userId="274c281c390bf037" providerId="LiveId" clId="{3508078A-B217-4536-9942-D96F763829E6}" dt="2021-02-17T08:53:47.307" v="0" actId="2696"/>
        <pc:sldMkLst>
          <pc:docMk/>
          <pc:sldMk cId="4046626086" sldId="286"/>
        </pc:sldMkLst>
      </pc:sldChg>
    </pc:docChg>
  </pc:docChgLst>
  <pc:docChgLst>
    <pc:chgData name="Shimakawa Ginga" userId="274c281c390bf037" providerId="LiveId" clId="{9CE26816-70B2-49A0-A62E-A42585A6DD91}"/>
    <pc:docChg chg="custSel addSld delSld modSld">
      <pc:chgData name="Shimakawa Ginga" userId="274c281c390bf037" providerId="LiveId" clId="{9CE26816-70B2-49A0-A62E-A42585A6DD91}" dt="2021-05-19T08:31:55.850" v="1104" actId="20577"/>
      <pc:docMkLst>
        <pc:docMk/>
      </pc:docMkLst>
      <pc:sldChg chg="addSp delSp modSp mod">
        <pc:chgData name="Shimakawa Ginga" userId="274c281c390bf037" providerId="LiveId" clId="{9CE26816-70B2-49A0-A62E-A42585A6DD91}" dt="2021-05-17T10:30:10.571" v="100" actId="6549"/>
        <pc:sldMkLst>
          <pc:docMk/>
          <pc:sldMk cId="3549244890" sldId="277"/>
        </pc:sldMkLst>
        <pc:spChg chg="mod">
          <ac:chgData name="Shimakawa Ginga" userId="274c281c390bf037" providerId="LiveId" clId="{9CE26816-70B2-49A0-A62E-A42585A6DD91}" dt="2021-05-17T10:30:10.571" v="100" actId="6549"/>
          <ac:spMkLst>
            <pc:docMk/>
            <pc:sldMk cId="3549244890" sldId="277"/>
            <ac:spMk id="5" creationId="{3C20FDA5-844D-4742-BAC3-4B023F6AF411}"/>
          </ac:spMkLst>
        </pc:spChg>
        <pc:picChg chg="add mod">
          <ac:chgData name="Shimakawa Ginga" userId="274c281c390bf037" providerId="LiveId" clId="{9CE26816-70B2-49A0-A62E-A42585A6DD91}" dt="2021-05-17T08:56:14.975" v="2" actId="1076"/>
          <ac:picMkLst>
            <pc:docMk/>
            <pc:sldMk cId="3549244890" sldId="277"/>
            <ac:picMk id="3" creationId="{356FCADC-C6C2-4332-8B11-CB9F0AD4BE13}"/>
          </ac:picMkLst>
        </pc:picChg>
        <pc:picChg chg="del">
          <ac:chgData name="Shimakawa Ginga" userId="274c281c390bf037" providerId="LiveId" clId="{9CE26816-70B2-49A0-A62E-A42585A6DD91}" dt="2021-05-17T08:55:54.541" v="0" actId="21"/>
          <ac:picMkLst>
            <pc:docMk/>
            <pc:sldMk cId="3549244890" sldId="277"/>
            <ac:picMk id="7" creationId="{1E54A8B8-4933-471F-9306-B6344A3B80E1}"/>
          </ac:picMkLst>
        </pc:picChg>
      </pc:sldChg>
      <pc:sldChg chg="addSp delSp modSp mod">
        <pc:chgData name="Shimakawa Ginga" userId="274c281c390bf037" providerId="LiveId" clId="{9CE26816-70B2-49A0-A62E-A42585A6DD91}" dt="2021-05-17T10:32:37.023" v="171" actId="6549"/>
        <pc:sldMkLst>
          <pc:docMk/>
          <pc:sldMk cId="4120038439" sldId="284"/>
        </pc:sldMkLst>
        <pc:spChg chg="mod">
          <ac:chgData name="Shimakawa Ginga" userId="274c281c390bf037" providerId="LiveId" clId="{9CE26816-70B2-49A0-A62E-A42585A6DD91}" dt="2021-05-17T10:32:37.023" v="171" actId="6549"/>
          <ac:spMkLst>
            <pc:docMk/>
            <pc:sldMk cId="4120038439" sldId="284"/>
            <ac:spMk id="5" creationId="{3C20FDA5-844D-4742-BAC3-4B023F6AF411}"/>
          </ac:spMkLst>
        </pc:spChg>
        <pc:picChg chg="add mod">
          <ac:chgData name="Shimakawa Ginga" userId="274c281c390bf037" providerId="LiveId" clId="{9CE26816-70B2-49A0-A62E-A42585A6DD91}" dt="2021-05-17T08:57:43.107" v="19" actId="1076"/>
          <ac:picMkLst>
            <pc:docMk/>
            <pc:sldMk cId="4120038439" sldId="284"/>
            <ac:picMk id="3" creationId="{87DC5A32-C3F5-4348-B6BE-7265C2075085}"/>
          </ac:picMkLst>
        </pc:picChg>
        <pc:picChg chg="del">
          <ac:chgData name="Shimakawa Ginga" userId="274c281c390bf037" providerId="LiveId" clId="{9CE26816-70B2-49A0-A62E-A42585A6DD91}" dt="2021-05-17T08:57:26.226" v="10" actId="21"/>
          <ac:picMkLst>
            <pc:docMk/>
            <pc:sldMk cId="4120038439" sldId="284"/>
            <ac:picMk id="13" creationId="{7073B138-AD1A-4191-A5A0-CF29FFE79ACF}"/>
          </ac:picMkLst>
        </pc:picChg>
      </pc:sldChg>
      <pc:sldChg chg="del">
        <pc:chgData name="Shimakawa Ginga" userId="274c281c390bf037" providerId="LiveId" clId="{9CE26816-70B2-49A0-A62E-A42585A6DD91}" dt="2021-05-17T09:01:23.851" v="21" actId="2696"/>
        <pc:sldMkLst>
          <pc:docMk/>
          <pc:sldMk cId="2420963065" sldId="287"/>
        </pc:sldMkLst>
      </pc:sldChg>
      <pc:sldChg chg="addSp delSp modSp mod">
        <pc:chgData name="Shimakawa Ginga" userId="274c281c390bf037" providerId="LiveId" clId="{9CE26816-70B2-49A0-A62E-A42585A6DD91}" dt="2021-05-17T10:39:57.929" v="454" actId="20577"/>
        <pc:sldMkLst>
          <pc:docMk/>
          <pc:sldMk cId="3542704458" sldId="288"/>
        </pc:sldMkLst>
        <pc:spChg chg="mod">
          <ac:chgData name="Shimakawa Ginga" userId="274c281c390bf037" providerId="LiveId" clId="{9CE26816-70B2-49A0-A62E-A42585A6DD91}" dt="2021-05-17T10:39:57.929" v="454" actId="20577"/>
          <ac:spMkLst>
            <pc:docMk/>
            <pc:sldMk cId="3542704458" sldId="288"/>
            <ac:spMk id="5" creationId="{3C20FDA5-844D-4742-BAC3-4B023F6AF411}"/>
          </ac:spMkLst>
        </pc:spChg>
        <pc:picChg chg="add mod">
          <ac:chgData name="Shimakawa Ginga" userId="274c281c390bf037" providerId="LiveId" clId="{9CE26816-70B2-49A0-A62E-A42585A6DD91}" dt="2021-05-17T09:42:22.309" v="55" actId="1076"/>
          <ac:picMkLst>
            <pc:docMk/>
            <pc:sldMk cId="3542704458" sldId="288"/>
            <ac:picMk id="3" creationId="{C0EF4783-8A79-4084-9DB9-1FF3B9E306B6}"/>
          </ac:picMkLst>
        </pc:picChg>
        <pc:picChg chg="del mod">
          <ac:chgData name="Shimakawa Ginga" userId="274c281c390bf037" providerId="LiveId" clId="{9CE26816-70B2-49A0-A62E-A42585A6DD91}" dt="2021-05-17T09:11:47.130" v="50" actId="21"/>
          <ac:picMkLst>
            <pc:docMk/>
            <pc:sldMk cId="3542704458" sldId="288"/>
            <ac:picMk id="6" creationId="{C26FB0E7-7652-472A-9CF3-05E13FADF72D}"/>
          </ac:picMkLst>
        </pc:picChg>
      </pc:sldChg>
      <pc:sldChg chg="del">
        <pc:chgData name="Shimakawa Ginga" userId="274c281c390bf037" providerId="LiveId" clId="{9CE26816-70B2-49A0-A62E-A42585A6DD91}" dt="2021-05-17T09:02:21.159" v="22" actId="2696"/>
        <pc:sldMkLst>
          <pc:docMk/>
          <pc:sldMk cId="121402441" sldId="289"/>
        </pc:sldMkLst>
      </pc:sldChg>
      <pc:sldChg chg="addSp delSp modSp add mod">
        <pc:chgData name="Shimakawa Ginga" userId="274c281c390bf037" providerId="LiveId" clId="{9CE26816-70B2-49A0-A62E-A42585A6DD91}" dt="2021-05-19T08:31:55.850" v="1104" actId="20577"/>
        <pc:sldMkLst>
          <pc:docMk/>
          <pc:sldMk cId="1440977981" sldId="289"/>
        </pc:sldMkLst>
        <pc:spChg chg="mod">
          <ac:chgData name="Shimakawa Ginga" userId="274c281c390bf037" providerId="LiveId" clId="{9CE26816-70B2-49A0-A62E-A42585A6DD91}" dt="2021-05-17T09:02:47.620" v="25" actId="20577"/>
          <ac:spMkLst>
            <pc:docMk/>
            <pc:sldMk cId="1440977981" sldId="289"/>
            <ac:spMk id="4" creationId="{9CC83B6F-C717-4187-81C4-9E7E47AB7D60}"/>
          </ac:spMkLst>
        </pc:spChg>
        <pc:spChg chg="mod">
          <ac:chgData name="Shimakawa Ginga" userId="274c281c390bf037" providerId="LiveId" clId="{9CE26816-70B2-49A0-A62E-A42585A6DD91}" dt="2021-05-19T08:31:55.850" v="1104" actId="20577"/>
          <ac:spMkLst>
            <pc:docMk/>
            <pc:sldMk cId="1440977981" sldId="289"/>
            <ac:spMk id="5" creationId="{3C20FDA5-844D-4742-BAC3-4B023F6AF411}"/>
          </ac:spMkLst>
        </pc:spChg>
        <pc:picChg chg="del">
          <ac:chgData name="Shimakawa Ginga" userId="274c281c390bf037" providerId="LiveId" clId="{9CE26816-70B2-49A0-A62E-A42585A6DD91}" dt="2021-05-17T09:03:54.578" v="36" actId="21"/>
          <ac:picMkLst>
            <pc:docMk/>
            <pc:sldMk cId="1440977981" sldId="289"/>
            <ac:picMk id="3" creationId="{87DC5A32-C3F5-4348-B6BE-7265C2075085}"/>
          </ac:picMkLst>
        </pc:picChg>
        <pc:picChg chg="add mod">
          <ac:chgData name="Shimakawa Ginga" userId="274c281c390bf037" providerId="LiveId" clId="{9CE26816-70B2-49A0-A62E-A42585A6DD91}" dt="2021-05-19T08:28:37.916" v="1089" actId="1076"/>
          <ac:picMkLst>
            <pc:docMk/>
            <pc:sldMk cId="1440977981" sldId="289"/>
            <ac:picMk id="3" creationId="{E952B989-F69B-40DD-9E8B-012D8F4C8475}"/>
          </ac:picMkLst>
        </pc:picChg>
        <pc:picChg chg="add del mod">
          <ac:chgData name="Shimakawa Ginga" userId="274c281c390bf037" providerId="LiveId" clId="{9CE26816-70B2-49A0-A62E-A42585A6DD91}" dt="2021-05-19T08:27:35.484" v="1084" actId="21"/>
          <ac:picMkLst>
            <pc:docMk/>
            <pc:sldMk cId="1440977981" sldId="289"/>
            <ac:picMk id="6" creationId="{6B55A3B1-9C14-4AFB-B077-841F1043ED05}"/>
          </ac:picMkLst>
        </pc:picChg>
      </pc:sldChg>
      <pc:sldChg chg="addSp delSp modSp add mod">
        <pc:chgData name="Shimakawa Ginga" userId="274c281c390bf037" providerId="LiveId" clId="{9CE26816-70B2-49A0-A62E-A42585A6DD91}" dt="2021-05-18T02:10:48.272" v="1083" actId="6549"/>
        <pc:sldMkLst>
          <pc:docMk/>
          <pc:sldMk cId="2726171640" sldId="290"/>
        </pc:sldMkLst>
        <pc:spChg chg="mod">
          <ac:chgData name="Shimakawa Ginga" userId="274c281c390bf037" providerId="LiveId" clId="{9CE26816-70B2-49A0-A62E-A42585A6DD91}" dt="2021-05-18T01:15:00.749" v="608" actId="20577"/>
          <ac:spMkLst>
            <pc:docMk/>
            <pc:sldMk cId="2726171640" sldId="290"/>
            <ac:spMk id="4" creationId="{9CC83B6F-C717-4187-81C4-9E7E47AB7D60}"/>
          </ac:spMkLst>
        </pc:spChg>
        <pc:spChg chg="mod">
          <ac:chgData name="Shimakawa Ginga" userId="274c281c390bf037" providerId="LiveId" clId="{9CE26816-70B2-49A0-A62E-A42585A6DD91}" dt="2021-05-18T02:10:48.272" v="1083" actId="6549"/>
          <ac:spMkLst>
            <pc:docMk/>
            <pc:sldMk cId="2726171640" sldId="290"/>
            <ac:spMk id="5" creationId="{3C20FDA5-844D-4742-BAC3-4B023F6AF411}"/>
          </ac:spMkLst>
        </pc:spChg>
        <pc:picChg chg="add mod">
          <ac:chgData name="Shimakawa Ginga" userId="274c281c390bf037" providerId="LiveId" clId="{9CE26816-70B2-49A0-A62E-A42585A6DD91}" dt="2021-05-18T02:04:30.129" v="615" actId="1076"/>
          <ac:picMkLst>
            <pc:docMk/>
            <pc:sldMk cId="2726171640" sldId="290"/>
            <ac:picMk id="3" creationId="{D737BA92-568B-446E-B808-EAB201BB4E12}"/>
          </ac:picMkLst>
        </pc:picChg>
        <pc:picChg chg="del">
          <ac:chgData name="Shimakawa Ginga" userId="274c281c390bf037" providerId="LiveId" clId="{9CE26816-70B2-49A0-A62E-A42585A6DD91}" dt="2021-05-18T01:14:53.964" v="604" actId="21"/>
          <ac:picMkLst>
            <pc:docMk/>
            <pc:sldMk cId="2726171640" sldId="290"/>
            <ac:picMk id="6" creationId="{C26FB0E7-7652-472A-9CF3-05E13FADF72D}"/>
          </ac:picMkLst>
        </pc:picChg>
      </pc:sldChg>
      <pc:sldChg chg="add">
        <pc:chgData name="Shimakawa Ginga" userId="274c281c390bf037" providerId="LiveId" clId="{9CE26816-70B2-49A0-A62E-A42585A6DD91}" dt="2021-05-18T01:14:50.768" v="603"/>
        <pc:sldMkLst>
          <pc:docMk/>
          <pc:sldMk cId="880047741" sldId="29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7362CF-9079-4A4E-904B-6836346FD8EB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7FA9BE-8C84-436E-8BCA-A2346A65F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3587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209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721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8543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764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898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593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150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123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68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465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369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9FA6E-64C2-4546-880B-8EA4E4180DE1}" type="datetimeFigureOut">
              <a:rPr kumimoji="1" lang="ja-JP" altLang="en-US" smtClean="0"/>
              <a:t>2021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A2871-6BDA-4095-A677-0FE4C5197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9492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8B1A076-40BB-4A39-9698-FAC6BF1D5B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567" y="106163"/>
            <a:ext cx="3273663" cy="8641597"/>
          </a:xfrm>
          <a:prstGeom prst="rect">
            <a:avLst/>
          </a:prstGeom>
        </p:spPr>
      </p:pic>
      <p:sp>
        <p:nvSpPr>
          <p:cNvPr id="5" name="テキスト ボックス 9">
            <a:extLst>
              <a:ext uri="{FF2B5EF4-FFF2-40B4-BE49-F238E27FC236}">
                <a16:creationId xmlns:a16="http://schemas.microsoft.com/office/drawing/2014/main" id="{3C20FDA5-844D-4742-BAC3-4B023F6AF4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4492" y="1247200"/>
            <a:ext cx="3071446" cy="5262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ffects of aminoacetonitrile on photosynthesis and photorespiration in the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iverwort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rchantia polymorpha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Tak-1). (A) Responses of chlorophyll fluorescence to CO</a:t>
            </a:r>
            <a:r>
              <a:rPr lang="en-US" altLang="ja-JP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epletion in the absence (black) and presence (orange) of 10 mM aminoacetonitrile. Fluorescence measuring light was illuminated to determine the minimum fluorescence from dark-adapted thalli (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US" altLang="ja-JP" sz="1200" baseline="-25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Short saturation flashes were applied every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 min to determine the maximum fluorescence from light-adapted thalli (F</a:t>
            </a:r>
            <a:r>
              <a:rPr lang="en-US" altLang="ja-JP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ʹ). Red actinic light (2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0 µmol photons m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2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1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as turned on at the time indicated by the black arrow.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</a:t>
            </a:r>
            <a:r>
              <a:rPr lang="en-US" altLang="ja-JP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as depleted by soda lime (&lt; 1 Pa) as indicated. Effective quantum yield of PSII, Y(II), determined at the times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dicated by red triangles were shown in Figure 1B. (B) Y(II) in ambient air, CO</a:t>
            </a:r>
            <a:r>
              <a:rPr lang="en-US" altLang="ja-JP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epletion, and high CO</a:t>
            </a:r>
            <a:r>
              <a:rPr lang="en-US" altLang="ja-JP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onditions in Tak-1. The data for high CO</a:t>
            </a:r>
            <a:r>
              <a:rPr lang="en-US" altLang="ja-JP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re obtained at 100 Pa CO</a:t>
            </a:r>
            <a:r>
              <a:rPr lang="en-US" altLang="ja-JP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ata shown are means with standard deviation (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= 3, biological replicates).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 The relationship between P700 oxidation and inferred reduction level of the plastoquinone pool (1 </a:t>
            </a:r>
            <a:r>
              <a:rPr lang="ja-JP" alt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qL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Plotted data were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btained when Y(II) in Figure 1B was determined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10">
            <a:extLst>
              <a:ext uri="{FF2B5EF4-FFF2-40B4-BE49-F238E27FC236}">
                <a16:creationId xmlns:a16="http://schemas.microsoft.com/office/drawing/2014/main" id="{FDEC9529-0B28-4DB4-A4F5-E057FAA127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367" y="8836223"/>
            <a:ext cx="663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 Shimakawa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Hanaw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3524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58</TotalTime>
  <Words>238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makawa Ginga</dc:creator>
  <cp:lastModifiedBy>Shimakawa Ginga</cp:lastModifiedBy>
  <cp:revision>76</cp:revision>
  <dcterms:created xsi:type="dcterms:W3CDTF">2020-05-19T08:44:21Z</dcterms:created>
  <dcterms:modified xsi:type="dcterms:W3CDTF">2021-06-28T12:35:08Z</dcterms:modified>
</cp:coreProperties>
</file>